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4572000" cy="3657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285920" y="685440"/>
            <a:ext cx="428616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7AB794-66D5-41FE-A816-F5897777290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2" name="PlaceHolder 1"/>
          <p:cNvSpPr>
            <a:spLocks noGrp="1"/>
          </p:cNvSpPr>
          <p:nvPr>
            <p:ph type="sldImg"/>
          </p:nvPr>
        </p:nvSpPr>
        <p:spPr>
          <a:xfrm>
            <a:off x="1285920" y="685800"/>
            <a:ext cx="4286160" cy="3429000"/>
          </a:xfrm>
          <a:prstGeom prst="rect">
            <a:avLst/>
          </a:prstGeom>
          <a:ln w="0">
            <a:noFill/>
          </a:ln>
        </p:spPr>
      </p:sp>
      <p:sp>
        <p:nvSpPr>
          <p:cNvPr id="60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Point out T219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288C7A-DBE7-4651-88F7-A627125D293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4800" cy="60948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ctr">
            <a:noAutofit/>
          </a:bodyPr>
          <a:p>
            <a:pPr indent="0" algn="ctr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28600" y="853560"/>
            <a:ext cx="411480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28600" y="2114280"/>
            <a:ext cx="411480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80614F-6305-4710-B2C3-193EA5E01C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4800" cy="60948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ctr">
            <a:noAutofit/>
          </a:bodyPr>
          <a:p>
            <a:pPr indent="0" algn="ctr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28600" y="853560"/>
            <a:ext cx="200772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337120" y="853560"/>
            <a:ext cx="200772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28600" y="2114280"/>
            <a:ext cx="200772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337120" y="2114280"/>
            <a:ext cx="200772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32B6B0-D384-46E4-88C0-3B3B87150F5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4800" cy="60948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ctr">
            <a:noAutofit/>
          </a:bodyPr>
          <a:p>
            <a:pPr indent="0" algn="ctr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28600" y="853560"/>
            <a:ext cx="132480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620000" y="853560"/>
            <a:ext cx="132480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011400" y="853560"/>
            <a:ext cx="132480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28600" y="2114280"/>
            <a:ext cx="132480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620000" y="2114280"/>
            <a:ext cx="132480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011400" y="2114280"/>
            <a:ext cx="132480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0EBDC4-1CAA-4766-9E43-DD4A4E4B859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4800" cy="60948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ctr">
            <a:noAutofit/>
          </a:bodyPr>
          <a:p>
            <a:pPr indent="0" algn="ctr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28600" y="853560"/>
            <a:ext cx="4114800" cy="241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00"/>
              </a:spcBef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1A7D15-D810-4911-BFA2-42ED752FBF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4800" cy="60948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ctr">
            <a:noAutofit/>
          </a:bodyPr>
          <a:p>
            <a:pPr indent="0" algn="ctr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28600" y="853560"/>
            <a:ext cx="4114800" cy="241308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D62EBB-2AA1-47E6-B3AD-B6552DCC8F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4800" cy="60948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ctr">
            <a:noAutofit/>
          </a:bodyPr>
          <a:p>
            <a:pPr indent="0" algn="ctr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28600" y="853560"/>
            <a:ext cx="2007720" cy="241308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337120" y="853560"/>
            <a:ext cx="2007720" cy="241308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CAC120-5B4E-4946-A970-2527916489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4800" cy="60948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ctr">
            <a:noAutofit/>
          </a:bodyPr>
          <a:p>
            <a:pPr indent="0" algn="ctr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FC3EF5-3025-47D5-BB01-C3A87A567E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28600" y="145800"/>
            <a:ext cx="4114800" cy="2826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00"/>
              </a:spcBef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1A405D-EB79-42B3-819A-098BE844D6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4800" cy="60948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ctr">
            <a:noAutofit/>
          </a:bodyPr>
          <a:p>
            <a:pPr indent="0" algn="ctr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28600" y="853560"/>
            <a:ext cx="200772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337120" y="853560"/>
            <a:ext cx="2007720" cy="241308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28600" y="2114280"/>
            <a:ext cx="200772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36B38B-CD27-4C81-BB39-64BCA80CF1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4800" cy="60948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ctr">
            <a:noAutofit/>
          </a:bodyPr>
          <a:p>
            <a:pPr indent="0" algn="ctr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28600" y="853560"/>
            <a:ext cx="2007720" cy="241308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337120" y="853560"/>
            <a:ext cx="200772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337120" y="2114280"/>
            <a:ext cx="200772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2779D5-4E26-4873-A551-FF36FF33ED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4800" cy="60948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ctr">
            <a:noAutofit/>
          </a:bodyPr>
          <a:p>
            <a:pPr indent="0" algn="ctr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28600" y="853560"/>
            <a:ext cx="200772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337120" y="853560"/>
            <a:ext cx="200772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28600" y="2114280"/>
            <a:ext cx="4114800" cy="115092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FA6C65-BC61-4882-A6E6-24E55B5258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28600" y="145800"/>
            <a:ext cx="4114800" cy="60948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ctr">
            <a:noAutofit/>
          </a:bodyPr>
          <a:p>
            <a:pPr indent="0" algn="ctr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28600" y="853560"/>
            <a:ext cx="4114800" cy="241308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rmAutofit/>
          </a:bodyPr>
          <a:p>
            <a:pPr marL="176040" indent="-176040">
              <a:spcBef>
                <a:spcPts val="400"/>
              </a:spcBef>
              <a:buClr>
                <a:srgbClr val="000000"/>
              </a:buClr>
              <a:buFont typeface="Arial"/>
              <a:buChar char="•"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382680" indent="-14760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587520" indent="-117720">
              <a:spcBef>
                <a:spcPts val="400"/>
              </a:spcBef>
              <a:buClr>
                <a:srgbClr val="000000"/>
              </a:buClr>
              <a:buFont typeface="Arial"/>
              <a:buChar char="•"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822240" indent="-11736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1057320" indent="-117360">
              <a:spcBef>
                <a:spcPts val="400"/>
              </a:spcBef>
              <a:buClr>
                <a:srgbClr val="000000"/>
              </a:buClr>
              <a:buFont typeface="Arial"/>
              <a:buChar char="»"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1057320" indent="-117360">
              <a:spcBef>
                <a:spcPts val="400"/>
              </a:spcBef>
              <a:buClr>
                <a:srgbClr val="000000"/>
              </a:buClr>
              <a:buFont typeface="Arial"/>
              <a:buChar char="»"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1057320" indent="-117360">
              <a:spcBef>
                <a:spcPts val="400"/>
              </a:spcBef>
              <a:buClr>
                <a:srgbClr val="000000"/>
              </a:buClr>
              <a:buFont typeface="Arial"/>
              <a:buChar char="»"/>
              <a:tabLst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28240" y="3330360"/>
            <a:ext cx="1066680" cy="25380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Autofit/>
          </a:bodyPr>
          <a:lstStyle>
            <a:lvl1pPr indent="0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  <a:defRPr b="0" lang="en-US" sz="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562040" y="3330360"/>
            <a:ext cx="1447920" cy="25380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Autofit/>
          </a:bodyPr>
          <a:lstStyle>
            <a:lvl1pPr indent="0" algn="ctr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  <a:defRPr b="0" lang="en-US" sz="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276360" y="3330360"/>
            <a:ext cx="1066680" cy="253800"/>
          </a:xfrm>
          <a:prstGeom prst="rect">
            <a:avLst/>
          </a:prstGeom>
          <a:noFill/>
          <a:ln w="0">
            <a:noFill/>
          </a:ln>
        </p:spPr>
        <p:txBody>
          <a:bodyPr lIns="47160" rIns="47160" tIns="23400" bIns="23400" anchor="t">
            <a:noAutofit/>
          </a:bodyPr>
          <a:lstStyle>
            <a:lvl1pPr indent="0" algn="r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  <a:defRPr b="0" lang="en-US" sz="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fld id="{9574634F-B863-4E18-8EA3-2940111CD4EA}" type="slidenum">
              <a:rPr b="0" lang="en-US" sz="7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"/>
          <p:cNvGrpSpPr/>
          <p:nvPr/>
        </p:nvGrpSpPr>
        <p:grpSpPr>
          <a:xfrm>
            <a:off x="76320" y="246240"/>
            <a:ext cx="4394160" cy="3283200"/>
            <a:chOff x="76320" y="246240"/>
            <a:chExt cx="4394160" cy="3283200"/>
          </a:xfrm>
        </p:grpSpPr>
        <p:sp>
          <p:nvSpPr>
            <p:cNvPr id="49" name=""/>
            <p:cNvSpPr/>
            <p:nvPr/>
          </p:nvSpPr>
          <p:spPr>
            <a:xfrm>
              <a:off x="203040" y="2079720"/>
              <a:ext cx="4191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41200" y="1103400"/>
              <a:ext cx="4152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93840" y="195732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31640" y="18763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79360" y="138744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41200" y="1469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93840" y="16732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79360" y="18352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41200" y="17542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17520" y="1712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41200" y="1550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55680" y="1184400"/>
              <a:ext cx="75960" cy="824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17520" y="159084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93840" y="159084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55680" y="13478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55680" y="18352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431640" y="118440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469800" y="1266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431640" y="1347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79360" y="118440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N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17520" y="19573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41200" y="1996920"/>
              <a:ext cx="76320" cy="82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41200" y="207972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660240" y="134784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41200" y="1103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03040" y="1022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65240" y="61596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65240" y="69696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03040" y="53496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55680" y="45252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03040" y="941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165240" y="86040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79360" y="49356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431640" y="45252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507960" y="45252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K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65240" y="77796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774720" y="61596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736560" y="53496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660240" y="49356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584280" y="45252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812880" y="69696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812880" y="94140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812880" y="102240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812880" y="86040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812880" y="77796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812880" y="110340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736560" y="1144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660240" y="118440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622440" y="12668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812880" y="138744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736560" y="138744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888840" y="1428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888840" y="1509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812880" y="15508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736560" y="159084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736560" y="17542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660240" y="1712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660240" y="1631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851040" y="18352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N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736560" y="1916280"/>
              <a:ext cx="7632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812880" y="17542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584280" y="195732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812880" y="1916280"/>
              <a:ext cx="7596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N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660240" y="1916280"/>
              <a:ext cx="7632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888840" y="21193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812880" y="211932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660240" y="20797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1041480" y="211932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736560" y="21193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965160" y="21193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660240" y="1996920"/>
              <a:ext cx="76320" cy="82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1117440" y="21193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1193760" y="20797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1193760" y="1712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1270080" y="16732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1117440" y="1712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1041480" y="17542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1117440" y="18763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1041480" y="18352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1193760" y="1916280"/>
              <a:ext cx="76320" cy="8064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1193760" y="1996920"/>
              <a:ext cx="76320" cy="82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1117440" y="138744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1041480" y="14288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1041480" y="15098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1117440" y="1550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1193760" y="1550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1270080" y="159084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965160" y="1144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W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965160" y="1225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041480" y="12254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1117440" y="1225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1193760" y="1266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1193760" y="1347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1041480" y="110340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1498680" y="11444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1422360" y="1144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Q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1346040" y="1103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1308240" y="102240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1270080" y="94140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1193760" y="941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1117440" y="981000"/>
              <a:ext cx="76320" cy="82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1041480" y="102240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Q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1422360" y="1631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1460520" y="1550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1536840" y="15508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1574640" y="1469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1498680" y="14288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1422360" y="1428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1346040" y="138744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N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1460520" y="1266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1384200" y="1306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1536840" y="12254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1612800" y="240516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1574640" y="2322360"/>
              <a:ext cx="76320" cy="828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1498680" y="228276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1384200" y="20797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Q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1346040" y="1996920"/>
              <a:ext cx="76320" cy="82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Q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1384200" y="1916280"/>
              <a:ext cx="7632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1460520" y="1916280"/>
              <a:ext cx="7632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1536840" y="1916280"/>
              <a:ext cx="7596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1612800" y="18763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1574640" y="179388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1650960" y="248616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1498680" y="17542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1422360" y="1712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2184480" y="236376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Q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2146320" y="252576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2146320" y="244476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2108160" y="26082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2070000" y="26892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K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1994040" y="268920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1841400" y="26892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1917720" y="26892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1765440" y="268920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1689120" y="26478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1689120" y="2567160"/>
              <a:ext cx="7632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1917720" y="19573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1841400" y="1996920"/>
              <a:ext cx="76320" cy="82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1841400" y="20797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2031840" y="2241720"/>
              <a:ext cx="7632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1879560" y="21607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1955880" y="220032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2108160" y="2241720"/>
              <a:ext cx="7632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2184480" y="228276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1727280" y="13064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1765440" y="138744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1841400" y="1428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1917720" y="1428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K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1841400" y="159084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1994040" y="14698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1994040" y="15508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1917720" y="159084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1765440" y="16318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1841400" y="17542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1765440" y="17128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622440" y="3218040"/>
              <a:ext cx="75960" cy="806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Q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698400" y="3218040"/>
              <a:ext cx="76320" cy="806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774720" y="3218040"/>
              <a:ext cx="76320" cy="806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851040" y="3218040"/>
              <a:ext cx="75960" cy="806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927000" y="3218040"/>
              <a:ext cx="76320" cy="806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584280" y="3135240"/>
              <a:ext cx="75960" cy="828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507960" y="309564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431640" y="305424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355680" y="3054240"/>
              <a:ext cx="7596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317520" y="3135240"/>
              <a:ext cx="76320" cy="828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317520" y="3218040"/>
              <a:ext cx="76320" cy="806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1231920" y="305424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1155600" y="309564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1079640" y="3135240"/>
              <a:ext cx="75960" cy="828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1003320" y="317664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1079640" y="2851200"/>
              <a:ext cx="7596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1155600" y="285120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1231920" y="2892600"/>
              <a:ext cx="76320" cy="806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1270080" y="2973240"/>
              <a:ext cx="7596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927000" y="2892600"/>
              <a:ext cx="76320" cy="806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851040" y="2932200"/>
              <a:ext cx="75960" cy="824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774720" y="297324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1003320" y="2892600"/>
              <a:ext cx="76320" cy="806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698400" y="301464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622440" y="3014640"/>
              <a:ext cx="7596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546120" y="297324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393840" y="2892600"/>
              <a:ext cx="75960" cy="806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469800" y="2932200"/>
              <a:ext cx="76320" cy="824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355680" y="2811600"/>
              <a:ext cx="75960" cy="8100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355680" y="2728800"/>
              <a:ext cx="75960" cy="828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355680" y="2647800"/>
              <a:ext cx="7596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307800" y="2576520"/>
              <a:ext cx="76320" cy="824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Q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312840" y="2495520"/>
              <a:ext cx="7596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388800" y="249552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465120" y="249552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517680" y="2562120"/>
              <a:ext cx="7596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555480" y="264312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860400" y="272412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Q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936720" y="2724120"/>
              <a:ext cx="7596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1008000" y="268920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Q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1117440" y="264780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1193760" y="264780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1270080" y="2647800"/>
              <a:ext cx="7596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774720" y="236376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1308240" y="2567160"/>
              <a:ext cx="75960" cy="806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851040" y="2405160"/>
              <a:ext cx="7596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927000" y="244476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1003320" y="244476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1079640" y="2405160"/>
              <a:ext cx="7596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1155600" y="236376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1231920" y="236376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1308240" y="2363760"/>
              <a:ext cx="7596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1384200" y="240516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1346040" y="248616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393840" y="2241720"/>
              <a:ext cx="75960" cy="806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469800" y="228276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546120" y="228276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622440" y="2282760"/>
              <a:ext cx="7596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698400" y="2322360"/>
              <a:ext cx="76320" cy="828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317520" y="2200320"/>
              <a:ext cx="76320" cy="824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241200" y="216072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708120" y="2724120"/>
              <a:ext cx="7596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631800" y="268452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784080" y="272412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1422360" y="2241720"/>
              <a:ext cx="7632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1384200" y="216072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1917720" y="17542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1994040" y="17542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2070000" y="179388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2070000" y="18763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1994040" y="1916280"/>
              <a:ext cx="7596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1765440" y="12254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2031840" y="1022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1955880" y="981000"/>
              <a:ext cx="75960" cy="82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1879560" y="1022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1879560" y="1103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1841400" y="118440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2070000" y="1103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2146320" y="1144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2222640" y="11444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2298600" y="118440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2260440" y="1266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2184480" y="12668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2108160" y="1306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2108160" y="138744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2184480" y="14288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2260440" y="1469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2298600" y="1550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2222640" y="159084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2146320" y="1631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2222640" y="16732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2298600" y="16732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2374920" y="1712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2336760" y="179388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2298600" y="18763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2413080" y="179388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2298600" y="207972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2298600" y="2160720"/>
              <a:ext cx="76320" cy="8100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2260440" y="1996920"/>
              <a:ext cx="76320" cy="82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2222640" y="1916280"/>
              <a:ext cx="7596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1574640" y="3218040"/>
              <a:ext cx="76320" cy="806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1498680" y="3218040"/>
              <a:ext cx="75960" cy="806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1498680" y="3135240"/>
              <a:ext cx="75960" cy="828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1536840" y="3054240"/>
              <a:ext cx="7596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1574640" y="297324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1650960" y="2932200"/>
              <a:ext cx="76320" cy="824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1727280" y="2932200"/>
              <a:ext cx="75960" cy="824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1803240" y="2932200"/>
              <a:ext cx="76320" cy="824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1879560" y="2932200"/>
              <a:ext cx="76320" cy="824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1955880" y="2932200"/>
              <a:ext cx="75960" cy="824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2031840" y="2892600"/>
              <a:ext cx="76320" cy="806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2108160" y="285120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2184480" y="2811600"/>
              <a:ext cx="7596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2260440" y="277020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2336760" y="2728800"/>
              <a:ext cx="76320" cy="828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2374920" y="2647800"/>
              <a:ext cx="76320" cy="8100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2413080" y="2567160"/>
              <a:ext cx="75960" cy="8064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2413080" y="2486160"/>
              <a:ext cx="75960" cy="8100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2374920" y="2405160"/>
              <a:ext cx="76320" cy="8100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2374920" y="2322360"/>
              <a:ext cx="76320" cy="8280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2336760" y="2241720"/>
              <a:ext cx="76320" cy="8064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2031840" y="317664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1955880" y="3218040"/>
              <a:ext cx="75960" cy="806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1879560" y="3218040"/>
              <a:ext cx="76320" cy="806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1803240" y="3218040"/>
              <a:ext cx="76320" cy="806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1727280" y="3218040"/>
              <a:ext cx="75960" cy="806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1650960" y="3218040"/>
              <a:ext cx="76320" cy="806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2108160" y="3135240"/>
              <a:ext cx="76320" cy="828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3403440" y="277020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3327480" y="2728800"/>
              <a:ext cx="75960" cy="828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3251160" y="277020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3174840" y="277020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3098880" y="2728800"/>
              <a:ext cx="75960" cy="828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3022560" y="268920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2946240" y="264780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2870280" y="2608200"/>
              <a:ext cx="75960" cy="8100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2793960" y="2567160"/>
              <a:ext cx="76320" cy="8064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2717640" y="2525760"/>
              <a:ext cx="76320" cy="8244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2641680" y="2567160"/>
              <a:ext cx="75960" cy="8064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2603520" y="2647800"/>
              <a:ext cx="76320" cy="8100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2565360" y="2728800"/>
              <a:ext cx="76320" cy="828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2527200" y="2811600"/>
              <a:ext cx="76320" cy="8100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2451240" y="2851200"/>
              <a:ext cx="75960" cy="8100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2413080" y="2932200"/>
              <a:ext cx="75960" cy="8244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2336760" y="2973240"/>
              <a:ext cx="76320" cy="8100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2260440" y="297324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2184480" y="2973240"/>
              <a:ext cx="7596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2146320" y="305424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3441600" y="285120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3441600" y="2932200"/>
              <a:ext cx="76320" cy="824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3365640" y="2973240"/>
              <a:ext cx="7596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N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3289320" y="297324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3365640" y="2525760"/>
              <a:ext cx="75960" cy="824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3441600" y="2525760"/>
              <a:ext cx="76320" cy="824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3517920" y="2567160"/>
              <a:ext cx="76320" cy="806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3594240" y="2608200"/>
              <a:ext cx="7596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3670200" y="285120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W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2908440" y="2973240"/>
              <a:ext cx="75960" cy="8100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3060720" y="297324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K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2832120" y="3014640"/>
              <a:ext cx="76320" cy="8100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2793960" y="309564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2793960" y="317664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2946240" y="3218040"/>
              <a:ext cx="76320" cy="806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3137040" y="2973240"/>
              <a:ext cx="7596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3213000" y="297324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2870280" y="3218040"/>
              <a:ext cx="75960" cy="806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3022560" y="3218040"/>
              <a:ext cx="76320" cy="806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3098880" y="3218040"/>
              <a:ext cx="75960" cy="806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3174840" y="3218040"/>
              <a:ext cx="76320" cy="806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3213000" y="3135240"/>
              <a:ext cx="76320" cy="828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2984400" y="297324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3289320" y="3135240"/>
              <a:ext cx="76320" cy="828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3365640" y="3135240"/>
              <a:ext cx="75960" cy="828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3441600" y="3135240"/>
              <a:ext cx="76320" cy="828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3517920" y="3135240"/>
              <a:ext cx="76320" cy="828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>
              <a:off x="3594240" y="3135240"/>
              <a:ext cx="75960" cy="828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>
              <a:off x="3670200" y="3135240"/>
              <a:ext cx="76320" cy="828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>
              <a:off x="3746520" y="3135240"/>
              <a:ext cx="76320" cy="8280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>
              <a:off x="3746520" y="3218040"/>
              <a:ext cx="76320" cy="806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>
              <a:off x="3632040" y="268920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>
              <a:off x="3822840" y="2932200"/>
              <a:ext cx="75960" cy="824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>
              <a:off x="3746520" y="2892600"/>
              <a:ext cx="76320" cy="806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"/>
            <p:cNvSpPr/>
            <p:nvPr/>
          </p:nvSpPr>
          <p:spPr>
            <a:xfrm>
              <a:off x="3632040" y="277020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"/>
            <p:cNvSpPr/>
            <p:nvPr/>
          </p:nvSpPr>
          <p:spPr>
            <a:xfrm>
              <a:off x="3898800" y="297324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Q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>
              <a:off x="3975120" y="301464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3822840" y="3218040"/>
              <a:ext cx="75960" cy="806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>
              <a:off x="3898800" y="3218040"/>
              <a:ext cx="76320" cy="806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>
              <a:off x="3975120" y="309564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>
              <a:off x="3975120" y="317664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>
              <a:off x="3289320" y="2525760"/>
              <a:ext cx="76320" cy="824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>
              <a:off x="3213000" y="2525760"/>
              <a:ext cx="76320" cy="824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>
              <a:off x="3137040" y="2525760"/>
              <a:ext cx="75960" cy="8244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"/>
            <p:cNvSpPr/>
            <p:nvPr/>
          </p:nvSpPr>
          <p:spPr>
            <a:xfrm>
              <a:off x="3060720" y="248616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"/>
            <p:cNvSpPr/>
            <p:nvPr/>
          </p:nvSpPr>
          <p:spPr>
            <a:xfrm>
              <a:off x="2946240" y="236376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"/>
            <p:cNvSpPr/>
            <p:nvPr/>
          </p:nvSpPr>
          <p:spPr>
            <a:xfrm>
              <a:off x="2908440" y="2282760"/>
              <a:ext cx="75960" cy="8100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"/>
            <p:cNvSpPr/>
            <p:nvPr/>
          </p:nvSpPr>
          <p:spPr>
            <a:xfrm>
              <a:off x="2717640" y="1550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"/>
            <p:cNvSpPr/>
            <p:nvPr/>
          </p:nvSpPr>
          <p:spPr>
            <a:xfrm>
              <a:off x="2870280" y="2200320"/>
              <a:ext cx="75960" cy="8244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"/>
            <p:cNvSpPr/>
            <p:nvPr/>
          </p:nvSpPr>
          <p:spPr>
            <a:xfrm>
              <a:off x="2984400" y="2444760"/>
              <a:ext cx="76320" cy="810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"/>
            <p:cNvSpPr/>
            <p:nvPr/>
          </p:nvSpPr>
          <p:spPr>
            <a:xfrm>
              <a:off x="2793960" y="2160720"/>
              <a:ext cx="76320" cy="8100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"/>
            <p:cNvSpPr/>
            <p:nvPr/>
          </p:nvSpPr>
          <p:spPr>
            <a:xfrm>
              <a:off x="2717640" y="2160720"/>
              <a:ext cx="76320" cy="8100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"/>
            <p:cNvSpPr/>
            <p:nvPr/>
          </p:nvSpPr>
          <p:spPr>
            <a:xfrm>
              <a:off x="2641680" y="2119320"/>
              <a:ext cx="75960" cy="81000"/>
            </a:xfrm>
            <a:prstGeom prst="ellipse">
              <a:avLst/>
            </a:prstGeom>
            <a:solidFill>
              <a:srgbClr val="ffffff">
                <a:alpha val="35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"/>
            <p:cNvSpPr/>
            <p:nvPr/>
          </p:nvSpPr>
          <p:spPr>
            <a:xfrm>
              <a:off x="2641680" y="159084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"/>
            <p:cNvSpPr/>
            <p:nvPr/>
          </p:nvSpPr>
          <p:spPr>
            <a:xfrm>
              <a:off x="2565360" y="1631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"/>
            <p:cNvSpPr/>
            <p:nvPr/>
          </p:nvSpPr>
          <p:spPr>
            <a:xfrm>
              <a:off x="2603520" y="1712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2679840" y="17542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"/>
            <p:cNvSpPr/>
            <p:nvPr/>
          </p:nvSpPr>
          <p:spPr>
            <a:xfrm>
              <a:off x="2755800" y="179388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"/>
            <p:cNvSpPr/>
            <p:nvPr/>
          </p:nvSpPr>
          <p:spPr>
            <a:xfrm>
              <a:off x="2793960" y="18763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"/>
            <p:cNvSpPr/>
            <p:nvPr/>
          </p:nvSpPr>
          <p:spPr>
            <a:xfrm>
              <a:off x="2565360" y="207972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W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"/>
            <p:cNvSpPr/>
            <p:nvPr/>
          </p:nvSpPr>
          <p:spPr>
            <a:xfrm>
              <a:off x="2641680" y="12668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"/>
            <p:cNvSpPr/>
            <p:nvPr/>
          </p:nvSpPr>
          <p:spPr>
            <a:xfrm>
              <a:off x="2565360" y="1306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"/>
            <p:cNvSpPr/>
            <p:nvPr/>
          </p:nvSpPr>
          <p:spPr>
            <a:xfrm>
              <a:off x="2641680" y="13478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"/>
            <p:cNvSpPr/>
            <p:nvPr/>
          </p:nvSpPr>
          <p:spPr>
            <a:xfrm>
              <a:off x="2717640" y="138744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"/>
            <p:cNvSpPr/>
            <p:nvPr/>
          </p:nvSpPr>
          <p:spPr>
            <a:xfrm>
              <a:off x="2793960" y="1428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"/>
            <p:cNvSpPr/>
            <p:nvPr/>
          </p:nvSpPr>
          <p:spPr>
            <a:xfrm>
              <a:off x="2793960" y="1509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"/>
            <p:cNvSpPr/>
            <p:nvPr/>
          </p:nvSpPr>
          <p:spPr>
            <a:xfrm>
              <a:off x="2717640" y="1266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"/>
            <p:cNvSpPr/>
            <p:nvPr/>
          </p:nvSpPr>
          <p:spPr>
            <a:xfrm>
              <a:off x="2603520" y="1144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"/>
            <p:cNvSpPr/>
            <p:nvPr/>
          </p:nvSpPr>
          <p:spPr>
            <a:xfrm>
              <a:off x="2527200" y="1103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"/>
            <p:cNvSpPr/>
            <p:nvPr/>
          </p:nvSpPr>
          <p:spPr>
            <a:xfrm>
              <a:off x="2527200" y="941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"/>
            <p:cNvSpPr/>
            <p:nvPr/>
          </p:nvSpPr>
          <p:spPr>
            <a:xfrm>
              <a:off x="2946240" y="860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"/>
            <p:cNvSpPr/>
            <p:nvPr/>
          </p:nvSpPr>
          <p:spPr>
            <a:xfrm>
              <a:off x="2870280" y="81900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"/>
            <p:cNvSpPr/>
            <p:nvPr/>
          </p:nvSpPr>
          <p:spPr>
            <a:xfrm>
              <a:off x="2717640" y="8190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"/>
            <p:cNvSpPr/>
            <p:nvPr/>
          </p:nvSpPr>
          <p:spPr>
            <a:xfrm>
              <a:off x="2641680" y="81900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"/>
            <p:cNvSpPr/>
            <p:nvPr/>
          </p:nvSpPr>
          <p:spPr>
            <a:xfrm>
              <a:off x="2565360" y="860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"/>
            <p:cNvSpPr/>
            <p:nvPr/>
          </p:nvSpPr>
          <p:spPr>
            <a:xfrm>
              <a:off x="2527200" y="1022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"/>
            <p:cNvSpPr/>
            <p:nvPr/>
          </p:nvSpPr>
          <p:spPr>
            <a:xfrm>
              <a:off x="2984400" y="941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"/>
            <p:cNvSpPr/>
            <p:nvPr/>
          </p:nvSpPr>
          <p:spPr>
            <a:xfrm>
              <a:off x="2679840" y="11444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"/>
            <p:cNvSpPr/>
            <p:nvPr/>
          </p:nvSpPr>
          <p:spPr>
            <a:xfrm>
              <a:off x="2755800" y="118440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"/>
            <p:cNvSpPr/>
            <p:nvPr/>
          </p:nvSpPr>
          <p:spPr>
            <a:xfrm>
              <a:off x="2565360" y="1996920"/>
              <a:ext cx="76320" cy="82800"/>
            </a:xfrm>
            <a:prstGeom prst="ellipse">
              <a:avLst/>
            </a:prstGeom>
            <a:solidFill>
              <a:srgbClr val="ffffff">
                <a:alpha val="40000"/>
              </a:srgbClr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"/>
            <p:cNvSpPr/>
            <p:nvPr/>
          </p:nvSpPr>
          <p:spPr>
            <a:xfrm>
              <a:off x="2717640" y="1916280"/>
              <a:ext cx="7632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"/>
            <p:cNvSpPr/>
            <p:nvPr/>
          </p:nvSpPr>
          <p:spPr>
            <a:xfrm>
              <a:off x="2984400" y="1631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"/>
            <p:cNvSpPr/>
            <p:nvPr/>
          </p:nvSpPr>
          <p:spPr>
            <a:xfrm>
              <a:off x="3060720" y="159084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"/>
            <p:cNvSpPr/>
            <p:nvPr/>
          </p:nvSpPr>
          <p:spPr>
            <a:xfrm>
              <a:off x="3137040" y="159084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N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"/>
            <p:cNvSpPr/>
            <p:nvPr/>
          </p:nvSpPr>
          <p:spPr>
            <a:xfrm>
              <a:off x="3213000" y="1550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"/>
            <p:cNvSpPr/>
            <p:nvPr/>
          </p:nvSpPr>
          <p:spPr>
            <a:xfrm>
              <a:off x="3098880" y="14288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"/>
            <p:cNvSpPr/>
            <p:nvPr/>
          </p:nvSpPr>
          <p:spPr>
            <a:xfrm>
              <a:off x="3022560" y="1428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"/>
            <p:cNvSpPr/>
            <p:nvPr/>
          </p:nvSpPr>
          <p:spPr>
            <a:xfrm>
              <a:off x="2946240" y="138744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"/>
            <p:cNvSpPr/>
            <p:nvPr/>
          </p:nvSpPr>
          <p:spPr>
            <a:xfrm>
              <a:off x="2946240" y="1306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"/>
            <p:cNvSpPr/>
            <p:nvPr/>
          </p:nvSpPr>
          <p:spPr>
            <a:xfrm>
              <a:off x="3022560" y="1266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"/>
            <p:cNvSpPr/>
            <p:nvPr/>
          </p:nvSpPr>
          <p:spPr>
            <a:xfrm>
              <a:off x="3098880" y="12254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"/>
            <p:cNvSpPr/>
            <p:nvPr/>
          </p:nvSpPr>
          <p:spPr>
            <a:xfrm>
              <a:off x="2984400" y="1103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W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"/>
            <p:cNvSpPr/>
            <p:nvPr/>
          </p:nvSpPr>
          <p:spPr>
            <a:xfrm>
              <a:off x="2793960" y="8190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"/>
            <p:cNvSpPr/>
            <p:nvPr/>
          </p:nvSpPr>
          <p:spPr>
            <a:xfrm>
              <a:off x="3022560" y="17542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"/>
            <p:cNvSpPr/>
            <p:nvPr/>
          </p:nvSpPr>
          <p:spPr>
            <a:xfrm>
              <a:off x="3174840" y="179388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"/>
            <p:cNvSpPr/>
            <p:nvPr/>
          </p:nvSpPr>
          <p:spPr>
            <a:xfrm>
              <a:off x="3137040" y="187632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K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"/>
            <p:cNvSpPr/>
            <p:nvPr/>
          </p:nvSpPr>
          <p:spPr>
            <a:xfrm>
              <a:off x="3098880" y="17542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>
              <a:off x="2946240" y="1712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"/>
            <p:cNvSpPr/>
            <p:nvPr/>
          </p:nvSpPr>
          <p:spPr>
            <a:xfrm>
              <a:off x="3060720" y="1144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"/>
            <p:cNvSpPr/>
            <p:nvPr/>
          </p:nvSpPr>
          <p:spPr>
            <a:xfrm>
              <a:off x="3174840" y="1469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"/>
            <p:cNvSpPr/>
            <p:nvPr/>
          </p:nvSpPr>
          <p:spPr>
            <a:xfrm>
              <a:off x="2984400" y="1022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"/>
            <p:cNvSpPr/>
            <p:nvPr/>
          </p:nvSpPr>
          <p:spPr>
            <a:xfrm>
              <a:off x="3060720" y="18763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"/>
            <p:cNvSpPr/>
            <p:nvPr/>
          </p:nvSpPr>
          <p:spPr>
            <a:xfrm>
              <a:off x="3022560" y="1996920"/>
              <a:ext cx="76320" cy="82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"/>
            <p:cNvSpPr/>
            <p:nvPr/>
          </p:nvSpPr>
          <p:spPr>
            <a:xfrm>
              <a:off x="2984400" y="1916280"/>
              <a:ext cx="7632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"/>
            <p:cNvSpPr/>
            <p:nvPr/>
          </p:nvSpPr>
          <p:spPr>
            <a:xfrm>
              <a:off x="3022560" y="20797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"/>
            <p:cNvSpPr/>
            <p:nvPr/>
          </p:nvSpPr>
          <p:spPr>
            <a:xfrm>
              <a:off x="3060720" y="21607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"/>
            <p:cNvSpPr/>
            <p:nvPr/>
          </p:nvSpPr>
          <p:spPr>
            <a:xfrm>
              <a:off x="3174840" y="228276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"/>
            <p:cNvSpPr/>
            <p:nvPr/>
          </p:nvSpPr>
          <p:spPr>
            <a:xfrm>
              <a:off x="3098880" y="2241720"/>
              <a:ext cx="7596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"/>
            <p:cNvSpPr/>
            <p:nvPr/>
          </p:nvSpPr>
          <p:spPr>
            <a:xfrm>
              <a:off x="3251160" y="228276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"/>
            <p:cNvSpPr/>
            <p:nvPr/>
          </p:nvSpPr>
          <p:spPr>
            <a:xfrm>
              <a:off x="3479760" y="21607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"/>
            <p:cNvSpPr/>
            <p:nvPr/>
          </p:nvSpPr>
          <p:spPr>
            <a:xfrm>
              <a:off x="3403440" y="228276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"/>
            <p:cNvSpPr/>
            <p:nvPr/>
          </p:nvSpPr>
          <p:spPr>
            <a:xfrm>
              <a:off x="3327480" y="228276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W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3479760" y="2241720"/>
              <a:ext cx="7632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"/>
            <p:cNvSpPr/>
            <p:nvPr/>
          </p:nvSpPr>
          <p:spPr>
            <a:xfrm>
              <a:off x="3517920" y="138744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"/>
            <p:cNvSpPr/>
            <p:nvPr/>
          </p:nvSpPr>
          <p:spPr>
            <a:xfrm>
              <a:off x="3594240" y="14288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"/>
            <p:cNvSpPr/>
            <p:nvPr/>
          </p:nvSpPr>
          <p:spPr>
            <a:xfrm>
              <a:off x="3632040" y="1509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"/>
            <p:cNvSpPr/>
            <p:nvPr/>
          </p:nvSpPr>
          <p:spPr>
            <a:xfrm>
              <a:off x="3556080" y="15508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"/>
            <p:cNvSpPr/>
            <p:nvPr/>
          </p:nvSpPr>
          <p:spPr>
            <a:xfrm>
              <a:off x="3479760" y="1550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"/>
            <p:cNvSpPr/>
            <p:nvPr/>
          </p:nvSpPr>
          <p:spPr>
            <a:xfrm>
              <a:off x="3403440" y="159084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"/>
            <p:cNvSpPr/>
            <p:nvPr/>
          </p:nvSpPr>
          <p:spPr>
            <a:xfrm>
              <a:off x="3403440" y="16732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"/>
            <p:cNvSpPr/>
            <p:nvPr/>
          </p:nvSpPr>
          <p:spPr>
            <a:xfrm>
              <a:off x="3479760" y="1712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"/>
            <p:cNvSpPr/>
            <p:nvPr/>
          </p:nvSpPr>
          <p:spPr>
            <a:xfrm>
              <a:off x="3556080" y="17128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"/>
            <p:cNvSpPr/>
            <p:nvPr/>
          </p:nvSpPr>
          <p:spPr>
            <a:xfrm>
              <a:off x="3632040" y="17542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"/>
            <p:cNvSpPr/>
            <p:nvPr/>
          </p:nvSpPr>
          <p:spPr>
            <a:xfrm>
              <a:off x="3632040" y="18352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"/>
            <p:cNvSpPr/>
            <p:nvPr/>
          </p:nvSpPr>
          <p:spPr>
            <a:xfrm>
              <a:off x="3556080" y="187632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"/>
            <p:cNvSpPr/>
            <p:nvPr/>
          </p:nvSpPr>
          <p:spPr>
            <a:xfrm>
              <a:off x="3517920" y="19573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"/>
            <p:cNvSpPr/>
            <p:nvPr/>
          </p:nvSpPr>
          <p:spPr>
            <a:xfrm>
              <a:off x="3441600" y="1996920"/>
              <a:ext cx="76320" cy="82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"/>
            <p:cNvSpPr/>
            <p:nvPr/>
          </p:nvSpPr>
          <p:spPr>
            <a:xfrm>
              <a:off x="3441600" y="20797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"/>
            <p:cNvSpPr/>
            <p:nvPr/>
          </p:nvSpPr>
          <p:spPr>
            <a:xfrm>
              <a:off x="3441600" y="1103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"/>
            <p:cNvSpPr/>
            <p:nvPr/>
          </p:nvSpPr>
          <p:spPr>
            <a:xfrm>
              <a:off x="3517920" y="1144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"/>
            <p:cNvSpPr/>
            <p:nvPr/>
          </p:nvSpPr>
          <p:spPr>
            <a:xfrm>
              <a:off x="3517920" y="1225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"/>
            <p:cNvSpPr/>
            <p:nvPr/>
          </p:nvSpPr>
          <p:spPr>
            <a:xfrm>
              <a:off x="3441600" y="1225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"/>
            <p:cNvSpPr/>
            <p:nvPr/>
          </p:nvSpPr>
          <p:spPr>
            <a:xfrm>
              <a:off x="3365640" y="12668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"/>
            <p:cNvSpPr/>
            <p:nvPr/>
          </p:nvSpPr>
          <p:spPr>
            <a:xfrm>
              <a:off x="3365640" y="13478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"/>
            <p:cNvSpPr/>
            <p:nvPr/>
          </p:nvSpPr>
          <p:spPr>
            <a:xfrm>
              <a:off x="3441600" y="138744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"/>
            <p:cNvSpPr/>
            <p:nvPr/>
          </p:nvSpPr>
          <p:spPr>
            <a:xfrm>
              <a:off x="3632040" y="738360"/>
              <a:ext cx="7632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"/>
            <p:cNvSpPr/>
            <p:nvPr/>
          </p:nvSpPr>
          <p:spPr>
            <a:xfrm>
              <a:off x="3556080" y="738360"/>
              <a:ext cx="7596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"/>
            <p:cNvSpPr/>
            <p:nvPr/>
          </p:nvSpPr>
          <p:spPr>
            <a:xfrm>
              <a:off x="3479760" y="738360"/>
              <a:ext cx="7632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"/>
            <p:cNvSpPr/>
            <p:nvPr/>
          </p:nvSpPr>
          <p:spPr>
            <a:xfrm>
              <a:off x="3403440" y="738360"/>
              <a:ext cx="7632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"/>
            <p:cNvSpPr/>
            <p:nvPr/>
          </p:nvSpPr>
          <p:spPr>
            <a:xfrm>
              <a:off x="3327480" y="738360"/>
              <a:ext cx="7596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"/>
            <p:cNvSpPr/>
            <p:nvPr/>
          </p:nvSpPr>
          <p:spPr>
            <a:xfrm>
              <a:off x="3289320" y="8190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"/>
            <p:cNvSpPr/>
            <p:nvPr/>
          </p:nvSpPr>
          <p:spPr>
            <a:xfrm>
              <a:off x="3289320" y="9000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"/>
            <p:cNvSpPr/>
            <p:nvPr/>
          </p:nvSpPr>
          <p:spPr>
            <a:xfrm>
              <a:off x="3327480" y="981000"/>
              <a:ext cx="75960" cy="82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"/>
            <p:cNvSpPr/>
            <p:nvPr/>
          </p:nvSpPr>
          <p:spPr>
            <a:xfrm>
              <a:off x="3403440" y="1022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"/>
            <p:cNvSpPr/>
            <p:nvPr/>
          </p:nvSpPr>
          <p:spPr>
            <a:xfrm>
              <a:off x="3822840" y="13064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"/>
            <p:cNvSpPr/>
            <p:nvPr/>
          </p:nvSpPr>
          <p:spPr>
            <a:xfrm>
              <a:off x="3898800" y="1266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3860640" y="118440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>
              <a:off x="3784680" y="11444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>
              <a:off x="3708360" y="1103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>
              <a:off x="3670200" y="1022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"/>
            <p:cNvSpPr/>
            <p:nvPr/>
          </p:nvSpPr>
          <p:spPr>
            <a:xfrm>
              <a:off x="3708360" y="941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"/>
            <p:cNvSpPr/>
            <p:nvPr/>
          </p:nvSpPr>
          <p:spPr>
            <a:xfrm>
              <a:off x="3708360" y="860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W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"/>
            <p:cNvSpPr/>
            <p:nvPr/>
          </p:nvSpPr>
          <p:spPr>
            <a:xfrm>
              <a:off x="3708360" y="77796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"/>
            <p:cNvSpPr/>
            <p:nvPr/>
          </p:nvSpPr>
          <p:spPr>
            <a:xfrm>
              <a:off x="3860640" y="18352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"/>
            <p:cNvSpPr/>
            <p:nvPr/>
          </p:nvSpPr>
          <p:spPr>
            <a:xfrm>
              <a:off x="3784680" y="179388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"/>
            <p:cNvSpPr/>
            <p:nvPr/>
          </p:nvSpPr>
          <p:spPr>
            <a:xfrm>
              <a:off x="3822840" y="17128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"/>
            <p:cNvSpPr/>
            <p:nvPr/>
          </p:nvSpPr>
          <p:spPr>
            <a:xfrm>
              <a:off x="3898800" y="16732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"/>
            <p:cNvSpPr/>
            <p:nvPr/>
          </p:nvSpPr>
          <p:spPr>
            <a:xfrm>
              <a:off x="3975120" y="1631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"/>
            <p:cNvSpPr/>
            <p:nvPr/>
          </p:nvSpPr>
          <p:spPr>
            <a:xfrm>
              <a:off x="3975120" y="1550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N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"/>
            <p:cNvSpPr/>
            <p:nvPr/>
          </p:nvSpPr>
          <p:spPr>
            <a:xfrm>
              <a:off x="3898800" y="1509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"/>
            <p:cNvSpPr/>
            <p:nvPr/>
          </p:nvSpPr>
          <p:spPr>
            <a:xfrm>
              <a:off x="3822840" y="14698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"/>
            <p:cNvSpPr/>
            <p:nvPr/>
          </p:nvSpPr>
          <p:spPr>
            <a:xfrm>
              <a:off x="3746520" y="1428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"/>
            <p:cNvSpPr/>
            <p:nvPr/>
          </p:nvSpPr>
          <p:spPr>
            <a:xfrm>
              <a:off x="3746520" y="1347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"/>
            <p:cNvSpPr/>
            <p:nvPr/>
          </p:nvSpPr>
          <p:spPr>
            <a:xfrm>
              <a:off x="3784680" y="2322360"/>
              <a:ext cx="75960" cy="82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"/>
            <p:cNvSpPr/>
            <p:nvPr/>
          </p:nvSpPr>
          <p:spPr>
            <a:xfrm>
              <a:off x="3746520" y="2241720"/>
              <a:ext cx="7632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K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"/>
            <p:cNvSpPr/>
            <p:nvPr/>
          </p:nvSpPr>
          <p:spPr>
            <a:xfrm>
              <a:off x="3784680" y="216072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"/>
            <p:cNvSpPr/>
            <p:nvPr/>
          </p:nvSpPr>
          <p:spPr>
            <a:xfrm>
              <a:off x="3822840" y="207972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"/>
            <p:cNvSpPr/>
            <p:nvPr/>
          </p:nvSpPr>
          <p:spPr>
            <a:xfrm>
              <a:off x="3784680" y="1996920"/>
              <a:ext cx="75960" cy="82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"/>
            <p:cNvSpPr/>
            <p:nvPr/>
          </p:nvSpPr>
          <p:spPr>
            <a:xfrm>
              <a:off x="3860640" y="19573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"/>
            <p:cNvSpPr/>
            <p:nvPr/>
          </p:nvSpPr>
          <p:spPr>
            <a:xfrm>
              <a:off x="3936960" y="19573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"/>
            <p:cNvSpPr/>
            <p:nvPr/>
          </p:nvSpPr>
          <p:spPr>
            <a:xfrm>
              <a:off x="4013280" y="195732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"/>
            <p:cNvSpPr/>
            <p:nvPr/>
          </p:nvSpPr>
          <p:spPr>
            <a:xfrm>
              <a:off x="4013280" y="187632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"/>
            <p:cNvSpPr/>
            <p:nvPr/>
          </p:nvSpPr>
          <p:spPr>
            <a:xfrm>
              <a:off x="3936960" y="18352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"/>
            <p:cNvSpPr/>
            <p:nvPr/>
          </p:nvSpPr>
          <p:spPr>
            <a:xfrm>
              <a:off x="4241880" y="236376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"/>
            <p:cNvSpPr/>
            <p:nvPr/>
          </p:nvSpPr>
          <p:spPr>
            <a:xfrm>
              <a:off x="4165560" y="236376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"/>
            <p:cNvSpPr/>
            <p:nvPr/>
          </p:nvSpPr>
          <p:spPr>
            <a:xfrm>
              <a:off x="4089240" y="236376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Q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"/>
            <p:cNvSpPr/>
            <p:nvPr/>
          </p:nvSpPr>
          <p:spPr>
            <a:xfrm>
              <a:off x="4013280" y="236376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K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"/>
            <p:cNvSpPr/>
            <p:nvPr/>
          </p:nvSpPr>
          <p:spPr>
            <a:xfrm>
              <a:off x="3936960" y="236376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"/>
            <p:cNvSpPr/>
            <p:nvPr/>
          </p:nvSpPr>
          <p:spPr>
            <a:xfrm>
              <a:off x="3860640" y="236376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"/>
            <p:cNvSpPr/>
            <p:nvPr/>
          </p:nvSpPr>
          <p:spPr>
            <a:xfrm>
              <a:off x="4356000" y="1916280"/>
              <a:ext cx="7632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"/>
            <p:cNvSpPr/>
            <p:nvPr/>
          </p:nvSpPr>
          <p:spPr>
            <a:xfrm>
              <a:off x="4280040" y="195732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"/>
            <p:cNvSpPr/>
            <p:nvPr/>
          </p:nvSpPr>
          <p:spPr>
            <a:xfrm>
              <a:off x="4203720" y="1996920"/>
              <a:ext cx="76320" cy="828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"/>
            <p:cNvSpPr/>
            <p:nvPr/>
          </p:nvSpPr>
          <p:spPr>
            <a:xfrm>
              <a:off x="4165560" y="20797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N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"/>
            <p:cNvSpPr/>
            <p:nvPr/>
          </p:nvSpPr>
          <p:spPr>
            <a:xfrm>
              <a:off x="4241880" y="211932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"/>
            <p:cNvSpPr/>
            <p:nvPr/>
          </p:nvSpPr>
          <p:spPr>
            <a:xfrm>
              <a:off x="4280040" y="220032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"/>
            <p:cNvSpPr/>
            <p:nvPr/>
          </p:nvSpPr>
          <p:spPr>
            <a:xfrm>
              <a:off x="4280040" y="228276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"/>
            <p:cNvSpPr/>
            <p:nvPr/>
          </p:nvSpPr>
          <p:spPr>
            <a:xfrm>
              <a:off x="4165560" y="138744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"/>
            <p:cNvSpPr/>
            <p:nvPr/>
          </p:nvSpPr>
          <p:spPr>
            <a:xfrm>
              <a:off x="4356000" y="1550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"/>
            <p:cNvSpPr/>
            <p:nvPr/>
          </p:nvSpPr>
          <p:spPr>
            <a:xfrm>
              <a:off x="4317840" y="1469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"/>
            <p:cNvSpPr/>
            <p:nvPr/>
          </p:nvSpPr>
          <p:spPr>
            <a:xfrm>
              <a:off x="4241880" y="14288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"/>
            <p:cNvSpPr/>
            <p:nvPr/>
          </p:nvSpPr>
          <p:spPr>
            <a:xfrm>
              <a:off x="4280040" y="159084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"/>
            <p:cNvSpPr/>
            <p:nvPr/>
          </p:nvSpPr>
          <p:spPr>
            <a:xfrm>
              <a:off x="4203720" y="1631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"/>
            <p:cNvSpPr/>
            <p:nvPr/>
          </p:nvSpPr>
          <p:spPr>
            <a:xfrm>
              <a:off x="4165560" y="17128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"/>
            <p:cNvSpPr/>
            <p:nvPr/>
          </p:nvSpPr>
          <p:spPr>
            <a:xfrm>
              <a:off x="4241880" y="175428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"/>
            <p:cNvSpPr/>
            <p:nvPr/>
          </p:nvSpPr>
          <p:spPr>
            <a:xfrm>
              <a:off x="4317840" y="179388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"/>
            <p:cNvSpPr/>
            <p:nvPr/>
          </p:nvSpPr>
          <p:spPr>
            <a:xfrm>
              <a:off x="4394160" y="183528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"/>
            <p:cNvSpPr/>
            <p:nvPr/>
          </p:nvSpPr>
          <p:spPr>
            <a:xfrm>
              <a:off x="4127400" y="1144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"/>
            <p:cNvSpPr/>
            <p:nvPr/>
          </p:nvSpPr>
          <p:spPr>
            <a:xfrm>
              <a:off x="4051440" y="110340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"/>
            <p:cNvSpPr/>
            <p:nvPr/>
          </p:nvSpPr>
          <p:spPr>
            <a:xfrm>
              <a:off x="4203720" y="1144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"/>
            <p:cNvSpPr/>
            <p:nvPr/>
          </p:nvSpPr>
          <p:spPr>
            <a:xfrm>
              <a:off x="4280040" y="118440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"/>
            <p:cNvSpPr/>
            <p:nvPr/>
          </p:nvSpPr>
          <p:spPr>
            <a:xfrm>
              <a:off x="4317840" y="1266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"/>
            <p:cNvSpPr/>
            <p:nvPr/>
          </p:nvSpPr>
          <p:spPr>
            <a:xfrm>
              <a:off x="4241880" y="126684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"/>
            <p:cNvSpPr/>
            <p:nvPr/>
          </p:nvSpPr>
          <p:spPr>
            <a:xfrm>
              <a:off x="4165560" y="13064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"/>
            <p:cNvSpPr/>
            <p:nvPr/>
          </p:nvSpPr>
          <p:spPr>
            <a:xfrm>
              <a:off x="4089240" y="134784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"/>
            <p:cNvSpPr/>
            <p:nvPr/>
          </p:nvSpPr>
          <p:spPr>
            <a:xfrm>
              <a:off x="4051440" y="33192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"/>
            <p:cNvSpPr/>
            <p:nvPr/>
          </p:nvSpPr>
          <p:spPr>
            <a:xfrm>
              <a:off x="4127400" y="3715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"/>
            <p:cNvSpPr/>
            <p:nvPr/>
          </p:nvSpPr>
          <p:spPr>
            <a:xfrm>
              <a:off x="4165560" y="45252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"/>
            <p:cNvSpPr/>
            <p:nvPr/>
          </p:nvSpPr>
          <p:spPr>
            <a:xfrm>
              <a:off x="4241880" y="61596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"/>
            <p:cNvSpPr/>
            <p:nvPr/>
          </p:nvSpPr>
          <p:spPr>
            <a:xfrm>
              <a:off x="4203720" y="53496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"/>
            <p:cNvSpPr/>
            <p:nvPr/>
          </p:nvSpPr>
          <p:spPr>
            <a:xfrm>
              <a:off x="4203720" y="69696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"/>
            <p:cNvSpPr/>
            <p:nvPr/>
          </p:nvSpPr>
          <p:spPr>
            <a:xfrm>
              <a:off x="4165560" y="77796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"/>
            <p:cNvSpPr/>
            <p:nvPr/>
          </p:nvSpPr>
          <p:spPr>
            <a:xfrm>
              <a:off x="4127400" y="860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"/>
            <p:cNvSpPr/>
            <p:nvPr/>
          </p:nvSpPr>
          <p:spPr>
            <a:xfrm>
              <a:off x="4089240" y="94140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"/>
            <p:cNvSpPr/>
            <p:nvPr/>
          </p:nvSpPr>
          <p:spPr>
            <a:xfrm>
              <a:off x="4051440" y="102240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"/>
            <p:cNvSpPr/>
            <p:nvPr/>
          </p:nvSpPr>
          <p:spPr>
            <a:xfrm>
              <a:off x="3403440" y="45252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"/>
            <p:cNvSpPr/>
            <p:nvPr/>
          </p:nvSpPr>
          <p:spPr>
            <a:xfrm>
              <a:off x="3479760" y="412920"/>
              <a:ext cx="76320" cy="80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"/>
            <p:cNvSpPr/>
            <p:nvPr/>
          </p:nvSpPr>
          <p:spPr>
            <a:xfrm>
              <a:off x="3517920" y="3319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N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"/>
            <p:cNvSpPr/>
            <p:nvPr/>
          </p:nvSpPr>
          <p:spPr>
            <a:xfrm>
              <a:off x="3594240" y="29052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"/>
            <p:cNvSpPr/>
            <p:nvPr/>
          </p:nvSpPr>
          <p:spPr>
            <a:xfrm>
              <a:off x="3670200" y="2905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"/>
            <p:cNvSpPr/>
            <p:nvPr/>
          </p:nvSpPr>
          <p:spPr>
            <a:xfrm>
              <a:off x="3746520" y="2905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"/>
            <p:cNvSpPr/>
            <p:nvPr/>
          </p:nvSpPr>
          <p:spPr>
            <a:xfrm>
              <a:off x="3822840" y="29052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"/>
            <p:cNvSpPr/>
            <p:nvPr/>
          </p:nvSpPr>
          <p:spPr>
            <a:xfrm>
              <a:off x="3898800" y="2905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"/>
            <p:cNvSpPr/>
            <p:nvPr/>
          </p:nvSpPr>
          <p:spPr>
            <a:xfrm>
              <a:off x="3975120" y="290520"/>
              <a:ext cx="7632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"/>
            <p:cNvSpPr/>
            <p:nvPr/>
          </p:nvSpPr>
          <p:spPr>
            <a:xfrm>
              <a:off x="3098880" y="45252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"/>
            <p:cNvSpPr/>
            <p:nvPr/>
          </p:nvSpPr>
          <p:spPr>
            <a:xfrm>
              <a:off x="3022560" y="45252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"/>
            <p:cNvSpPr/>
            <p:nvPr/>
          </p:nvSpPr>
          <p:spPr>
            <a:xfrm>
              <a:off x="3174840" y="45252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"/>
            <p:cNvSpPr/>
            <p:nvPr/>
          </p:nvSpPr>
          <p:spPr>
            <a:xfrm>
              <a:off x="3251160" y="452520"/>
              <a:ext cx="7632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"/>
            <p:cNvSpPr/>
            <p:nvPr/>
          </p:nvSpPr>
          <p:spPr>
            <a:xfrm>
              <a:off x="3327480" y="452520"/>
              <a:ext cx="75960" cy="824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I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"/>
            <p:cNvSpPr/>
            <p:nvPr/>
          </p:nvSpPr>
          <p:spPr>
            <a:xfrm>
              <a:off x="109440" y="3306600"/>
              <a:ext cx="309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NH</a:t>
              </a:r>
              <a:r>
                <a:rPr b="1" lang="en-US" sz="8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3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Arial"/>
                  <a:ea typeface="宋体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"/>
            <p:cNvSpPr/>
            <p:nvPr/>
          </p:nvSpPr>
          <p:spPr>
            <a:xfrm>
              <a:off x="2685960" y="399960"/>
              <a:ext cx="374760" cy="168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OO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Arial"/>
                  <a:ea typeface="宋体"/>
                </a:rPr>
                <a:t>-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"/>
            <p:cNvSpPr/>
            <p:nvPr/>
          </p:nvSpPr>
          <p:spPr>
            <a:xfrm>
              <a:off x="127080" y="1955880"/>
              <a:ext cx="137880" cy="13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"/>
            <p:cNvSpPr/>
            <p:nvPr/>
          </p:nvSpPr>
          <p:spPr>
            <a:xfrm>
              <a:off x="493560" y="1960560"/>
              <a:ext cx="137880" cy="13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"/>
            <p:cNvSpPr/>
            <p:nvPr/>
          </p:nvSpPr>
          <p:spPr>
            <a:xfrm>
              <a:off x="1089000" y="1960560"/>
              <a:ext cx="137880" cy="13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"/>
            <p:cNvSpPr/>
            <p:nvPr/>
          </p:nvSpPr>
          <p:spPr>
            <a:xfrm>
              <a:off x="1384200" y="1960560"/>
              <a:ext cx="137880" cy="13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"/>
            <p:cNvSpPr/>
            <p:nvPr/>
          </p:nvSpPr>
          <p:spPr>
            <a:xfrm>
              <a:off x="1722600" y="1962000"/>
              <a:ext cx="137880" cy="13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"/>
            <p:cNvSpPr/>
            <p:nvPr/>
          </p:nvSpPr>
          <p:spPr>
            <a:xfrm>
              <a:off x="2141640" y="1962000"/>
              <a:ext cx="137880" cy="13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"/>
            <p:cNvSpPr/>
            <p:nvPr/>
          </p:nvSpPr>
          <p:spPr>
            <a:xfrm>
              <a:off x="2465280" y="1957320"/>
              <a:ext cx="137880" cy="13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"/>
            <p:cNvSpPr/>
            <p:nvPr/>
          </p:nvSpPr>
          <p:spPr>
            <a:xfrm>
              <a:off x="2903400" y="1957320"/>
              <a:ext cx="137880" cy="13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"/>
            <p:cNvSpPr/>
            <p:nvPr/>
          </p:nvSpPr>
          <p:spPr>
            <a:xfrm>
              <a:off x="3327480" y="1962000"/>
              <a:ext cx="137880" cy="13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"/>
            <p:cNvSpPr/>
            <p:nvPr/>
          </p:nvSpPr>
          <p:spPr>
            <a:xfrm>
              <a:off x="3642120" y="1957320"/>
              <a:ext cx="180360" cy="13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"/>
            <p:cNvSpPr/>
            <p:nvPr/>
          </p:nvSpPr>
          <p:spPr>
            <a:xfrm>
              <a:off x="4065840" y="1957320"/>
              <a:ext cx="180360" cy="13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1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"/>
            <p:cNvSpPr/>
            <p:nvPr/>
          </p:nvSpPr>
          <p:spPr>
            <a:xfrm>
              <a:off x="4432320" y="167328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"/>
            <p:cNvSpPr/>
            <p:nvPr/>
          </p:nvSpPr>
          <p:spPr>
            <a:xfrm>
              <a:off x="2641680" y="1957320"/>
              <a:ext cx="75960" cy="810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"/>
            <p:cNvSpPr/>
            <p:nvPr/>
          </p:nvSpPr>
          <p:spPr>
            <a:xfrm>
              <a:off x="228600" y="246240"/>
              <a:ext cx="725400" cy="168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Extracellula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"/>
            <p:cNvSpPr/>
            <p:nvPr/>
          </p:nvSpPr>
          <p:spPr>
            <a:xfrm>
              <a:off x="501840" y="3360600"/>
              <a:ext cx="674280" cy="168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tracellula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"/>
            <p:cNvSpPr/>
            <p:nvPr/>
          </p:nvSpPr>
          <p:spPr>
            <a:xfrm>
              <a:off x="76320" y="2784600"/>
              <a:ext cx="294840" cy="13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600" spc="-1" strike="noStrike">
                  <a:solidFill>
                    <a:srgbClr val="ff0000"/>
                  </a:solidFill>
                  <a:latin typeface="Arial"/>
                  <a:ea typeface="Arial"/>
                </a:rPr>
                <a:t>D29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"/>
            <p:cNvSpPr/>
            <p:nvPr/>
          </p:nvSpPr>
          <p:spPr>
            <a:xfrm>
              <a:off x="1050840" y="2617920"/>
              <a:ext cx="76320" cy="8100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ctr">
              <a:noAutofit/>
            </a:bodyPr>
            <a:p>
              <a:pPr algn="ctr"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"/>
            <p:cNvSpPr/>
            <p:nvPr/>
          </p:nvSpPr>
          <p:spPr>
            <a:xfrm>
              <a:off x="1165320" y="1800360"/>
              <a:ext cx="325080" cy="13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600" spc="-1" strike="noStrike">
                  <a:solidFill>
                    <a:srgbClr val="ff0000"/>
                  </a:solidFill>
                  <a:latin typeface="Arial"/>
                  <a:ea typeface="Arial"/>
                </a:rPr>
                <a:t>A138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"/>
            <p:cNvSpPr/>
            <p:nvPr/>
          </p:nvSpPr>
          <p:spPr>
            <a:xfrm>
              <a:off x="3636000" y="3013200"/>
              <a:ext cx="328320" cy="13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47160" rIns="47160" tIns="23400" bIns="23400" anchor="t">
              <a:spAutoFit/>
            </a:bodyPr>
            <a:p>
              <a:pPr>
                <a:tabLst>
                  <a:tab algn="l" pos="0"/>
                  <a:tab algn="l" pos="469800"/>
                  <a:tab algn="l" pos="939960"/>
                  <a:tab algn="l" pos="1409760"/>
                  <a:tab algn="l" pos="1879560"/>
                  <a:tab algn="l" pos="2349360"/>
                  <a:tab algn="l" pos="2819520"/>
                  <a:tab algn="l" pos="3289320"/>
                  <a:tab algn="l" pos="3759120"/>
                  <a:tab algn="l" pos="4229280"/>
                  <a:tab algn="l" pos="4699080"/>
                  <a:tab algn="l" pos="5168880"/>
                  <a:tab algn="l" pos="5638680"/>
                  <a:tab algn="l" pos="6108840"/>
                  <a:tab algn="l" pos="6578640"/>
                  <a:tab algn="l" pos="7048440"/>
                  <a:tab algn="l" pos="7518240"/>
                  <a:tab algn="l" pos="7988400"/>
                  <a:tab algn="l" pos="8458200"/>
                  <a:tab algn="l" pos="8928000"/>
                  <a:tab algn="l" pos="9398160"/>
                </a:tabLst>
              </a:pPr>
              <a:r>
                <a:rPr b="1" lang="en-US" sz="600" spc="-1" strike="noStrike">
                  <a:solidFill>
                    <a:srgbClr val="ff0000"/>
                  </a:solidFill>
                  <a:latin typeface="Arial"/>
                  <a:ea typeface="Arial"/>
                </a:rPr>
                <a:t>D326E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01" name=""/>
          <p:cNvSpPr/>
          <p:nvPr/>
        </p:nvSpPr>
        <p:spPr>
          <a:xfrm>
            <a:off x="2310120" y="3451320"/>
            <a:ext cx="229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69800"/>
                <a:tab algn="l" pos="939960"/>
                <a:tab algn="l" pos="1409760"/>
                <a:tab algn="l" pos="1879560"/>
                <a:tab algn="l" pos="2349360"/>
                <a:tab algn="l" pos="2819520"/>
                <a:tab algn="l" pos="3289320"/>
                <a:tab algn="l" pos="3759120"/>
                <a:tab algn="l" pos="4229280"/>
                <a:tab algn="l" pos="4699080"/>
                <a:tab algn="l" pos="5168880"/>
                <a:tab algn="l" pos="5638680"/>
                <a:tab algn="l" pos="6108840"/>
                <a:tab algn="l" pos="6578640"/>
                <a:tab algn="l" pos="7048440"/>
                <a:tab algn="l" pos="7518240"/>
                <a:tab algn="l" pos="7988400"/>
                <a:tab algn="l" pos="8458200"/>
                <a:tab algn="l" pos="8928000"/>
                <a:tab algn="l" pos="939816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upplementary Figure S2 Adamsen et al R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03T19:02:33Z</dcterms:created>
  <dc:creator>Horace Ho</dc:creator>
  <dc:description/>
  <dc:language>en-US</dc:language>
  <cp:lastModifiedBy>thb</cp:lastModifiedBy>
  <dcterms:modified xsi:type="dcterms:W3CDTF">2014-05-11T13:14:49Z</dcterms:modified>
  <cp:revision>59</cp:revision>
  <dc:subject/>
  <dc:title>Slide 1</dc:title>
</cp:coreProperties>
</file>